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16200438" cy="611981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8" userDrawn="1">
          <p15:clr>
            <a:srgbClr val="A4A3A4"/>
          </p15:clr>
        </p15:guide>
        <p15:guide id="2" pos="51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021"/>
    <a:srgbClr val="3BC5A2"/>
    <a:srgbClr val="26309A"/>
    <a:srgbClr val="0093C5"/>
    <a:srgbClr val="A60042"/>
    <a:srgbClr val="F059B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 showGuides="1">
      <p:cViewPr varScale="1">
        <p:scale>
          <a:sx n="100" d="100"/>
          <a:sy n="100" d="100"/>
        </p:scale>
        <p:origin x="184" y="912"/>
      </p:cViewPr>
      <p:guideLst>
        <p:guide orient="horz" pos="1928"/>
        <p:guide pos="51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25055" y="1001553"/>
            <a:ext cx="12150329" cy="2130602"/>
          </a:xfrm>
        </p:spPr>
        <p:txBody>
          <a:bodyPr anchor="b"/>
          <a:lstStyle>
            <a:lvl1pPr algn="ctr">
              <a:defRPr sz="535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3214319"/>
            <a:ext cx="12150329" cy="1477538"/>
          </a:xfrm>
        </p:spPr>
        <p:txBody>
          <a:bodyPr/>
          <a:lstStyle>
            <a:lvl1pPr marL="0" indent="0" algn="ctr">
              <a:buNone/>
              <a:defRPr sz="2142"/>
            </a:lvl1pPr>
            <a:lvl2pPr marL="408005" indent="0" algn="ctr">
              <a:buNone/>
              <a:defRPr sz="1785"/>
            </a:lvl2pPr>
            <a:lvl3pPr marL="816011" indent="0" algn="ctr">
              <a:buNone/>
              <a:defRPr sz="1606"/>
            </a:lvl3pPr>
            <a:lvl4pPr marL="1224016" indent="0" algn="ctr">
              <a:buNone/>
              <a:defRPr sz="1428"/>
            </a:lvl4pPr>
            <a:lvl5pPr marL="1632021" indent="0" algn="ctr">
              <a:buNone/>
              <a:defRPr sz="1428"/>
            </a:lvl5pPr>
            <a:lvl6pPr marL="2040026" indent="0" algn="ctr">
              <a:buNone/>
              <a:defRPr sz="1428"/>
            </a:lvl6pPr>
            <a:lvl7pPr marL="2448032" indent="0" algn="ctr">
              <a:buNone/>
              <a:defRPr sz="1428"/>
            </a:lvl7pPr>
            <a:lvl8pPr marL="2856037" indent="0" algn="ctr">
              <a:buNone/>
              <a:defRPr sz="1428"/>
            </a:lvl8pPr>
            <a:lvl9pPr marL="3264042" indent="0" algn="ctr">
              <a:buNone/>
              <a:defRPr sz="142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570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327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39" y="325823"/>
            <a:ext cx="3493219" cy="518625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0" y="325823"/>
            <a:ext cx="10277153" cy="518625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752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725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2" y="1525704"/>
            <a:ext cx="13972878" cy="2545672"/>
          </a:xfrm>
        </p:spPr>
        <p:txBody>
          <a:bodyPr anchor="b"/>
          <a:lstStyle>
            <a:lvl1pPr>
              <a:defRPr sz="535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2" y="4095459"/>
            <a:ext cx="13972878" cy="1338709"/>
          </a:xfrm>
        </p:spPr>
        <p:txBody>
          <a:bodyPr/>
          <a:lstStyle>
            <a:lvl1pPr marL="0" indent="0">
              <a:buNone/>
              <a:defRPr sz="2142">
                <a:solidFill>
                  <a:schemeClr val="tx1">
                    <a:tint val="75000"/>
                  </a:schemeClr>
                </a:solidFill>
              </a:defRPr>
            </a:lvl1pPr>
            <a:lvl2pPr marL="408005" indent="0">
              <a:buNone/>
              <a:defRPr sz="1785">
                <a:solidFill>
                  <a:schemeClr val="tx1">
                    <a:tint val="75000"/>
                  </a:schemeClr>
                </a:solidFill>
              </a:defRPr>
            </a:lvl2pPr>
            <a:lvl3pPr marL="816011" indent="0">
              <a:buNone/>
              <a:defRPr sz="1606">
                <a:solidFill>
                  <a:schemeClr val="tx1">
                    <a:tint val="75000"/>
                  </a:schemeClr>
                </a:solidFill>
              </a:defRPr>
            </a:lvl3pPr>
            <a:lvl4pPr marL="1224016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4pPr>
            <a:lvl5pPr marL="1632021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5pPr>
            <a:lvl6pPr marL="2040026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6pPr>
            <a:lvl7pPr marL="2448032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7pPr>
            <a:lvl8pPr marL="2856037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8pPr>
            <a:lvl9pPr marL="3264042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8934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1629117"/>
            <a:ext cx="6885186" cy="3882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1629117"/>
            <a:ext cx="6885186" cy="3882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27727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325824"/>
            <a:ext cx="13972878" cy="118288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1" y="1500205"/>
            <a:ext cx="6853544" cy="735227"/>
          </a:xfrm>
        </p:spPr>
        <p:txBody>
          <a:bodyPr anchor="b"/>
          <a:lstStyle>
            <a:lvl1pPr marL="0" indent="0">
              <a:buNone/>
              <a:defRPr sz="2142" b="1"/>
            </a:lvl1pPr>
            <a:lvl2pPr marL="408005" indent="0">
              <a:buNone/>
              <a:defRPr sz="1785" b="1"/>
            </a:lvl2pPr>
            <a:lvl3pPr marL="816011" indent="0">
              <a:buNone/>
              <a:defRPr sz="1606" b="1"/>
            </a:lvl3pPr>
            <a:lvl4pPr marL="1224016" indent="0">
              <a:buNone/>
              <a:defRPr sz="1428" b="1"/>
            </a:lvl4pPr>
            <a:lvl5pPr marL="1632021" indent="0">
              <a:buNone/>
              <a:defRPr sz="1428" b="1"/>
            </a:lvl5pPr>
            <a:lvl6pPr marL="2040026" indent="0">
              <a:buNone/>
              <a:defRPr sz="1428" b="1"/>
            </a:lvl6pPr>
            <a:lvl7pPr marL="2448032" indent="0">
              <a:buNone/>
              <a:defRPr sz="1428" b="1"/>
            </a:lvl7pPr>
            <a:lvl8pPr marL="2856037" indent="0">
              <a:buNone/>
              <a:defRPr sz="1428" b="1"/>
            </a:lvl8pPr>
            <a:lvl9pPr marL="3264042" indent="0">
              <a:buNone/>
              <a:defRPr sz="1428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1" y="2235432"/>
            <a:ext cx="6853544" cy="32879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2" y="1500205"/>
            <a:ext cx="6887296" cy="735227"/>
          </a:xfrm>
        </p:spPr>
        <p:txBody>
          <a:bodyPr anchor="b"/>
          <a:lstStyle>
            <a:lvl1pPr marL="0" indent="0">
              <a:buNone/>
              <a:defRPr sz="2142" b="1"/>
            </a:lvl1pPr>
            <a:lvl2pPr marL="408005" indent="0">
              <a:buNone/>
              <a:defRPr sz="1785" b="1"/>
            </a:lvl2pPr>
            <a:lvl3pPr marL="816011" indent="0">
              <a:buNone/>
              <a:defRPr sz="1606" b="1"/>
            </a:lvl3pPr>
            <a:lvl4pPr marL="1224016" indent="0">
              <a:buNone/>
              <a:defRPr sz="1428" b="1"/>
            </a:lvl4pPr>
            <a:lvl5pPr marL="1632021" indent="0">
              <a:buNone/>
              <a:defRPr sz="1428" b="1"/>
            </a:lvl5pPr>
            <a:lvl6pPr marL="2040026" indent="0">
              <a:buNone/>
              <a:defRPr sz="1428" b="1"/>
            </a:lvl6pPr>
            <a:lvl7pPr marL="2448032" indent="0">
              <a:buNone/>
              <a:defRPr sz="1428" b="1"/>
            </a:lvl7pPr>
            <a:lvl8pPr marL="2856037" indent="0">
              <a:buNone/>
              <a:defRPr sz="1428" b="1"/>
            </a:lvl8pPr>
            <a:lvl9pPr marL="3264042" indent="0">
              <a:buNone/>
              <a:defRPr sz="1428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2" y="2235432"/>
            <a:ext cx="6887296" cy="32879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933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017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3870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1" y="407988"/>
            <a:ext cx="5225062" cy="1427956"/>
          </a:xfrm>
        </p:spPr>
        <p:txBody>
          <a:bodyPr anchor="b"/>
          <a:lstStyle>
            <a:lvl1pPr>
              <a:defRPr sz="285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881140"/>
            <a:ext cx="8201472" cy="4349034"/>
          </a:xfrm>
        </p:spPr>
        <p:txBody>
          <a:bodyPr/>
          <a:lstStyle>
            <a:lvl1pPr>
              <a:defRPr sz="2856"/>
            </a:lvl1pPr>
            <a:lvl2pPr>
              <a:defRPr sz="2499"/>
            </a:lvl2pPr>
            <a:lvl3pPr>
              <a:defRPr sz="2142"/>
            </a:lvl3pPr>
            <a:lvl4pPr>
              <a:defRPr sz="1785"/>
            </a:lvl4pPr>
            <a:lvl5pPr>
              <a:defRPr sz="1785"/>
            </a:lvl5pPr>
            <a:lvl6pPr>
              <a:defRPr sz="1785"/>
            </a:lvl6pPr>
            <a:lvl7pPr>
              <a:defRPr sz="1785"/>
            </a:lvl7pPr>
            <a:lvl8pPr>
              <a:defRPr sz="1785"/>
            </a:lvl8pPr>
            <a:lvl9pPr>
              <a:defRPr sz="178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1" y="1835944"/>
            <a:ext cx="5225062" cy="3401313"/>
          </a:xfrm>
        </p:spPr>
        <p:txBody>
          <a:bodyPr/>
          <a:lstStyle>
            <a:lvl1pPr marL="0" indent="0">
              <a:buNone/>
              <a:defRPr sz="1428"/>
            </a:lvl1pPr>
            <a:lvl2pPr marL="408005" indent="0">
              <a:buNone/>
              <a:defRPr sz="1249"/>
            </a:lvl2pPr>
            <a:lvl3pPr marL="816011" indent="0">
              <a:buNone/>
              <a:defRPr sz="1071"/>
            </a:lvl3pPr>
            <a:lvl4pPr marL="1224016" indent="0">
              <a:buNone/>
              <a:defRPr sz="892"/>
            </a:lvl4pPr>
            <a:lvl5pPr marL="1632021" indent="0">
              <a:buNone/>
              <a:defRPr sz="892"/>
            </a:lvl5pPr>
            <a:lvl6pPr marL="2040026" indent="0">
              <a:buNone/>
              <a:defRPr sz="892"/>
            </a:lvl6pPr>
            <a:lvl7pPr marL="2448032" indent="0">
              <a:buNone/>
              <a:defRPr sz="892"/>
            </a:lvl7pPr>
            <a:lvl8pPr marL="2856037" indent="0">
              <a:buNone/>
              <a:defRPr sz="892"/>
            </a:lvl8pPr>
            <a:lvl9pPr marL="3264042" indent="0">
              <a:buNone/>
              <a:defRPr sz="892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977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1" y="407988"/>
            <a:ext cx="5225062" cy="1427956"/>
          </a:xfrm>
        </p:spPr>
        <p:txBody>
          <a:bodyPr anchor="b"/>
          <a:lstStyle>
            <a:lvl1pPr>
              <a:defRPr sz="285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881140"/>
            <a:ext cx="8201472" cy="4349034"/>
          </a:xfrm>
        </p:spPr>
        <p:txBody>
          <a:bodyPr anchor="t"/>
          <a:lstStyle>
            <a:lvl1pPr marL="0" indent="0">
              <a:buNone/>
              <a:defRPr sz="2856"/>
            </a:lvl1pPr>
            <a:lvl2pPr marL="408005" indent="0">
              <a:buNone/>
              <a:defRPr sz="2499"/>
            </a:lvl2pPr>
            <a:lvl3pPr marL="816011" indent="0">
              <a:buNone/>
              <a:defRPr sz="2142"/>
            </a:lvl3pPr>
            <a:lvl4pPr marL="1224016" indent="0">
              <a:buNone/>
              <a:defRPr sz="1785"/>
            </a:lvl4pPr>
            <a:lvl5pPr marL="1632021" indent="0">
              <a:buNone/>
              <a:defRPr sz="1785"/>
            </a:lvl5pPr>
            <a:lvl6pPr marL="2040026" indent="0">
              <a:buNone/>
              <a:defRPr sz="1785"/>
            </a:lvl6pPr>
            <a:lvl7pPr marL="2448032" indent="0">
              <a:buNone/>
              <a:defRPr sz="1785"/>
            </a:lvl7pPr>
            <a:lvl8pPr marL="2856037" indent="0">
              <a:buNone/>
              <a:defRPr sz="1785"/>
            </a:lvl8pPr>
            <a:lvl9pPr marL="3264042" indent="0">
              <a:buNone/>
              <a:defRPr sz="178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1" y="1835944"/>
            <a:ext cx="5225062" cy="3401313"/>
          </a:xfrm>
        </p:spPr>
        <p:txBody>
          <a:bodyPr/>
          <a:lstStyle>
            <a:lvl1pPr marL="0" indent="0">
              <a:buNone/>
              <a:defRPr sz="1428"/>
            </a:lvl1pPr>
            <a:lvl2pPr marL="408005" indent="0">
              <a:buNone/>
              <a:defRPr sz="1249"/>
            </a:lvl2pPr>
            <a:lvl3pPr marL="816011" indent="0">
              <a:buNone/>
              <a:defRPr sz="1071"/>
            </a:lvl3pPr>
            <a:lvl4pPr marL="1224016" indent="0">
              <a:buNone/>
              <a:defRPr sz="892"/>
            </a:lvl4pPr>
            <a:lvl5pPr marL="1632021" indent="0">
              <a:buNone/>
              <a:defRPr sz="892"/>
            </a:lvl5pPr>
            <a:lvl6pPr marL="2040026" indent="0">
              <a:buNone/>
              <a:defRPr sz="892"/>
            </a:lvl6pPr>
            <a:lvl7pPr marL="2448032" indent="0">
              <a:buNone/>
              <a:defRPr sz="892"/>
            </a:lvl7pPr>
            <a:lvl8pPr marL="2856037" indent="0">
              <a:buNone/>
              <a:defRPr sz="892"/>
            </a:lvl8pPr>
            <a:lvl9pPr marL="3264042" indent="0">
              <a:buNone/>
              <a:defRPr sz="892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7357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325824"/>
            <a:ext cx="13972878" cy="1182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1629117"/>
            <a:ext cx="13972878" cy="38829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5672161"/>
            <a:ext cx="3645099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28885-3FB3-DA40-82DB-67C3A4606A1D}" type="datetimeFigureOut">
              <a:rPr kumimoji="1" lang="ja-JP" altLang="en-US" smtClean="0"/>
              <a:t>2019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5672161"/>
            <a:ext cx="5467648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5672161"/>
            <a:ext cx="3645099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D447F-BAA9-364F-939D-FD079CBAC5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935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16011" rtl="0" eaLnBrk="1" latinLnBrk="0" hangingPunct="1">
        <a:lnSpc>
          <a:spcPct val="90000"/>
        </a:lnSpc>
        <a:spcBef>
          <a:spcPct val="0"/>
        </a:spcBef>
        <a:buNone/>
        <a:defRPr kumimoji="1" sz="39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4003" indent="-204003" algn="l" defTabSz="816011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kumimoji="1" sz="2499" kern="1200">
          <a:solidFill>
            <a:schemeClr val="tx1"/>
          </a:solidFill>
          <a:latin typeface="+mn-lt"/>
          <a:ea typeface="+mn-ea"/>
          <a:cs typeface="+mn-cs"/>
        </a:defRPr>
      </a:lvl1pPr>
      <a:lvl2pPr marL="612008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2142" kern="1200">
          <a:solidFill>
            <a:schemeClr val="tx1"/>
          </a:solidFill>
          <a:latin typeface="+mn-lt"/>
          <a:ea typeface="+mn-ea"/>
          <a:cs typeface="+mn-cs"/>
        </a:defRPr>
      </a:lvl2pPr>
      <a:lvl3pPr marL="1020013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785" kern="1200">
          <a:solidFill>
            <a:schemeClr val="tx1"/>
          </a:solidFill>
          <a:latin typeface="+mn-lt"/>
          <a:ea typeface="+mn-ea"/>
          <a:cs typeface="+mn-cs"/>
        </a:defRPr>
      </a:lvl3pPr>
      <a:lvl4pPr marL="1428018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4pPr>
      <a:lvl5pPr marL="1836024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5pPr>
      <a:lvl6pPr marL="2244029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6pPr>
      <a:lvl7pPr marL="2652034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7pPr>
      <a:lvl8pPr marL="3060040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8pPr>
      <a:lvl9pPr marL="3468045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1pPr>
      <a:lvl2pPr marL="408005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816011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3pPr>
      <a:lvl4pPr marL="1224016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4pPr>
      <a:lvl5pPr marL="1632021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5pPr>
      <a:lvl6pPr marL="2040026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6pPr>
      <a:lvl7pPr marL="2448032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7pPr>
      <a:lvl8pPr marL="2856037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8pPr>
      <a:lvl9pPr marL="3264042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>
            <a:extLst>
              <a:ext uri="{FF2B5EF4-FFF2-40B4-BE49-F238E27FC236}">
                <a16:creationId xmlns:a16="http://schemas.microsoft.com/office/drawing/2014/main" id="{62139281-C502-D340-A47A-D9898DE5A60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173762" y="1372487"/>
            <a:ext cx="5029201" cy="4114800"/>
          </a:xfrm>
          <a:prstGeom prst="rect">
            <a:avLst/>
          </a:prstGeom>
        </p:spPr>
      </p:pic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0F96A21E-12E3-6B4F-BF85-074E406D56CE}"/>
              </a:ext>
            </a:extLst>
          </p:cNvPr>
          <p:cNvGrpSpPr/>
          <p:nvPr/>
        </p:nvGrpSpPr>
        <p:grpSpPr>
          <a:xfrm>
            <a:off x="998141" y="2618992"/>
            <a:ext cx="1933200" cy="600450"/>
            <a:chOff x="1844430" y="358925"/>
            <a:chExt cx="1921836" cy="600450"/>
          </a:xfrm>
        </p:grpSpPr>
        <p:grpSp>
          <p:nvGrpSpPr>
            <p:cNvPr id="36" name="グループ化 35">
              <a:extLst>
                <a:ext uri="{FF2B5EF4-FFF2-40B4-BE49-F238E27FC236}">
                  <a16:creationId xmlns:a16="http://schemas.microsoft.com/office/drawing/2014/main" id="{3DBABCE9-7257-EE4D-AF10-6FDE31F9CDBA}"/>
                </a:ext>
              </a:extLst>
            </p:cNvPr>
            <p:cNvGrpSpPr/>
            <p:nvPr/>
          </p:nvGrpSpPr>
          <p:grpSpPr>
            <a:xfrm>
              <a:off x="2009670" y="391613"/>
              <a:ext cx="1521565" cy="535074"/>
              <a:chOff x="2009670" y="424301"/>
              <a:chExt cx="1521565" cy="535074"/>
            </a:xfrm>
          </p:grpSpPr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E83503ED-4F90-5146-85A6-EF8234B675DE}"/>
                  </a:ext>
                </a:extLst>
              </p:cNvPr>
              <p:cNvGrpSpPr/>
              <p:nvPr/>
            </p:nvGrpSpPr>
            <p:grpSpPr>
              <a:xfrm>
                <a:off x="2009670" y="636210"/>
                <a:ext cx="1521565" cy="323165"/>
                <a:chOff x="-240703" y="483810"/>
                <a:chExt cx="1521565" cy="323165"/>
              </a:xfrm>
            </p:grpSpPr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23602220-2CA2-E849-A878-BE4A6DD95DBE}"/>
                    </a:ext>
                  </a:extLst>
                </p:cNvPr>
                <p:cNvSpPr txBox="1"/>
                <p:nvPr/>
              </p:nvSpPr>
              <p:spPr>
                <a:xfrm>
                  <a:off x="1153" y="483810"/>
                  <a:ext cx="1279709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gh-RWT</a:t>
                  </a:r>
                  <a:r>
                    <a:rPr lang="en-US" altLang="ja-JP" sz="15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W</a:t>
                  </a:r>
                  <a:endParaRPr lang="ja-JP" altLang="en-US" sz="1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6" name="直線コネクタ 25">
                  <a:extLst>
                    <a:ext uri="{FF2B5EF4-FFF2-40B4-BE49-F238E27FC236}">
                      <a16:creationId xmlns:a16="http://schemas.microsoft.com/office/drawing/2014/main" id="{3987A84D-F53F-C44D-A7FA-A7AD8BAFF6FD}"/>
                    </a:ext>
                  </a:extLst>
                </p:cNvPr>
                <p:cNvCxnSpPr/>
                <p:nvPr/>
              </p:nvCxnSpPr>
              <p:spPr>
                <a:xfrm>
                  <a:off x="-240703" y="645392"/>
                  <a:ext cx="277200" cy="0"/>
                </a:xfrm>
                <a:prstGeom prst="line">
                  <a:avLst/>
                </a:prstGeom>
                <a:ln w="22860">
                  <a:solidFill>
                    <a:srgbClr val="A60042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" name="グループ化 29">
                <a:extLst>
                  <a:ext uri="{FF2B5EF4-FFF2-40B4-BE49-F238E27FC236}">
                    <a16:creationId xmlns:a16="http://schemas.microsoft.com/office/drawing/2014/main" id="{22926740-459B-3945-AA33-4C70E723A1FE}"/>
                  </a:ext>
                </a:extLst>
              </p:cNvPr>
              <p:cNvGrpSpPr/>
              <p:nvPr/>
            </p:nvGrpSpPr>
            <p:grpSpPr>
              <a:xfrm>
                <a:off x="2009670" y="424301"/>
                <a:ext cx="1478539" cy="323165"/>
                <a:chOff x="1857270" y="194771"/>
                <a:chExt cx="1478539" cy="323165"/>
              </a:xfrm>
            </p:grpSpPr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4A8D0560-44CA-7B4A-ABA6-AA3A0B394D50}"/>
                    </a:ext>
                  </a:extLst>
                </p:cNvPr>
                <p:cNvSpPr txBox="1"/>
                <p:nvPr/>
              </p:nvSpPr>
              <p:spPr>
                <a:xfrm>
                  <a:off x="2099126" y="194771"/>
                  <a:ext cx="1236683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w-RWT</a:t>
                  </a:r>
                  <a:r>
                    <a:rPr lang="en-US" altLang="ja-JP" sz="15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W</a:t>
                  </a:r>
                  <a:endParaRPr lang="ja-JP" altLang="en-US" sz="1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2" name="直線コネクタ 31">
                  <a:extLst>
                    <a:ext uri="{FF2B5EF4-FFF2-40B4-BE49-F238E27FC236}">
                      <a16:creationId xmlns:a16="http://schemas.microsoft.com/office/drawing/2014/main" id="{4A5B5B7E-F5CF-0D47-982E-6A14FE2253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57270" y="356353"/>
                  <a:ext cx="277200" cy="1"/>
                </a:xfrm>
                <a:prstGeom prst="line">
                  <a:avLst/>
                </a:prstGeom>
                <a:ln w="22860">
                  <a:solidFill>
                    <a:srgbClr val="F059B4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C088072A-B33B-2945-A784-B7AEB73E2AB1}"/>
                </a:ext>
              </a:extLst>
            </p:cNvPr>
            <p:cNvSpPr/>
            <p:nvPr/>
          </p:nvSpPr>
          <p:spPr>
            <a:xfrm>
              <a:off x="1844430" y="358925"/>
              <a:ext cx="1921836" cy="600450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ja-JP" altLang="en-US"/>
            </a:p>
          </p:txBody>
        </p:sp>
      </p:grp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C08374B-8568-1848-8A3E-9C1113E002EB}"/>
              </a:ext>
            </a:extLst>
          </p:cNvPr>
          <p:cNvSpPr txBox="1"/>
          <p:nvPr/>
        </p:nvSpPr>
        <p:spPr>
          <a:xfrm>
            <a:off x="158894" y="634112"/>
            <a:ext cx="2783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a) Stratified by RWT</a:t>
            </a:r>
            <a:r>
              <a:rPr lang="en-US" altLang="ja-JP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W</a:t>
            </a: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0496BF4-605C-D646-8933-0E41662283AC}"/>
              </a:ext>
            </a:extLst>
          </p:cNvPr>
          <p:cNvSpPr txBox="1"/>
          <p:nvPr/>
        </p:nvSpPr>
        <p:spPr>
          <a:xfrm>
            <a:off x="3013506" y="1372487"/>
            <a:ext cx="18769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og-rank, </a:t>
            </a:r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03</a:t>
            </a:r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図 41">
            <a:extLst>
              <a:ext uri="{FF2B5EF4-FFF2-40B4-BE49-F238E27FC236}">
                <a16:creationId xmlns:a16="http://schemas.microsoft.com/office/drawing/2014/main" id="{5A6D99BD-5B69-234B-8B64-C6C9573A40F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5585619" y="1372487"/>
            <a:ext cx="5029200" cy="4114800"/>
          </a:xfrm>
          <a:prstGeom prst="rect">
            <a:avLst/>
          </a:prstGeom>
        </p:spPr>
      </p:pic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B5DB1445-7B12-724F-98F4-88139F9AB508}"/>
              </a:ext>
            </a:extLst>
          </p:cNvPr>
          <p:cNvGrpSpPr/>
          <p:nvPr/>
        </p:nvGrpSpPr>
        <p:grpSpPr>
          <a:xfrm>
            <a:off x="6407214" y="2619390"/>
            <a:ext cx="1977306" cy="600450"/>
            <a:chOff x="2095534" y="-953508"/>
            <a:chExt cx="1965683" cy="600450"/>
          </a:xfrm>
        </p:grpSpPr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F67B9369-4B04-A547-9A2C-786E8A4E4472}"/>
                </a:ext>
              </a:extLst>
            </p:cNvPr>
            <p:cNvGrpSpPr/>
            <p:nvPr/>
          </p:nvGrpSpPr>
          <p:grpSpPr>
            <a:xfrm>
              <a:off x="2260774" y="-920820"/>
              <a:ext cx="1800443" cy="535074"/>
              <a:chOff x="2260774" y="-888132"/>
              <a:chExt cx="1800443" cy="535074"/>
            </a:xfrm>
          </p:grpSpPr>
          <p:grpSp>
            <p:nvGrpSpPr>
              <p:cNvPr id="48" name="グループ化 47">
                <a:extLst>
                  <a:ext uri="{FF2B5EF4-FFF2-40B4-BE49-F238E27FC236}">
                    <a16:creationId xmlns:a16="http://schemas.microsoft.com/office/drawing/2014/main" id="{F86B3A8B-BD65-464E-B78B-33190A9D0E27}"/>
                  </a:ext>
                </a:extLst>
              </p:cNvPr>
              <p:cNvGrpSpPr/>
              <p:nvPr/>
            </p:nvGrpSpPr>
            <p:grpSpPr>
              <a:xfrm>
                <a:off x="2260774" y="-676223"/>
                <a:ext cx="1800443" cy="323165"/>
                <a:chOff x="10401" y="-828623"/>
                <a:chExt cx="1800443" cy="323165"/>
              </a:xfrm>
            </p:grpSpPr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DB9B2744-0CE7-2843-B8A7-94EA72457DFC}"/>
                    </a:ext>
                  </a:extLst>
                </p:cNvPr>
                <p:cNvSpPr txBox="1"/>
                <p:nvPr/>
              </p:nvSpPr>
              <p:spPr>
                <a:xfrm>
                  <a:off x="252258" y="-828623"/>
                  <a:ext cx="1558586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gh-RWT</a:t>
                  </a:r>
                  <a:r>
                    <a:rPr lang="en-US" altLang="ja-JP" sz="15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VS+PW</a:t>
                  </a:r>
                  <a:endParaRPr lang="ja-JP" altLang="en-US" sz="1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3" name="直線コネクタ 52">
                  <a:extLst>
                    <a:ext uri="{FF2B5EF4-FFF2-40B4-BE49-F238E27FC236}">
                      <a16:creationId xmlns:a16="http://schemas.microsoft.com/office/drawing/2014/main" id="{6F419FC8-D93A-1145-9A7B-B5893E62CB07}"/>
                    </a:ext>
                  </a:extLst>
                </p:cNvPr>
                <p:cNvCxnSpPr/>
                <p:nvPr/>
              </p:nvCxnSpPr>
              <p:spPr>
                <a:xfrm>
                  <a:off x="10401" y="-667041"/>
                  <a:ext cx="277200" cy="0"/>
                </a:xfrm>
                <a:prstGeom prst="line">
                  <a:avLst/>
                </a:prstGeom>
                <a:ln w="22860">
                  <a:solidFill>
                    <a:srgbClr val="26309A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9" name="グループ化 48">
                <a:extLst>
                  <a:ext uri="{FF2B5EF4-FFF2-40B4-BE49-F238E27FC236}">
                    <a16:creationId xmlns:a16="http://schemas.microsoft.com/office/drawing/2014/main" id="{4EABDD91-211C-1241-8F12-46E944F9A0FC}"/>
                  </a:ext>
                </a:extLst>
              </p:cNvPr>
              <p:cNvGrpSpPr/>
              <p:nvPr/>
            </p:nvGrpSpPr>
            <p:grpSpPr>
              <a:xfrm>
                <a:off x="2260774" y="-888132"/>
                <a:ext cx="1757414" cy="323165"/>
                <a:chOff x="2108374" y="-1117662"/>
                <a:chExt cx="1757414" cy="323165"/>
              </a:xfrm>
            </p:grpSpPr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EB74737C-37A0-B841-B3F5-EA2116DFBD3F}"/>
                    </a:ext>
                  </a:extLst>
                </p:cNvPr>
                <p:cNvSpPr txBox="1"/>
                <p:nvPr/>
              </p:nvSpPr>
              <p:spPr>
                <a:xfrm>
                  <a:off x="2350230" y="-1117662"/>
                  <a:ext cx="1515558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w-RWT</a:t>
                  </a:r>
                  <a:r>
                    <a:rPr lang="en-US" altLang="ja-JP" sz="15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VS+PW</a:t>
                  </a:r>
                  <a:endParaRPr lang="ja-JP" altLang="en-US" sz="1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1" name="直線コネクタ 50">
                  <a:extLst>
                    <a:ext uri="{FF2B5EF4-FFF2-40B4-BE49-F238E27FC236}">
                      <a16:creationId xmlns:a16="http://schemas.microsoft.com/office/drawing/2014/main" id="{05DFC384-1751-E249-A268-BD59C6DAA4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08374" y="-956080"/>
                  <a:ext cx="277200" cy="1"/>
                </a:xfrm>
                <a:prstGeom prst="line">
                  <a:avLst/>
                </a:prstGeom>
                <a:ln w="22860">
                  <a:solidFill>
                    <a:srgbClr val="0093C5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370FE06D-19B1-AF4F-88F9-B137D9C344D9}"/>
                </a:ext>
              </a:extLst>
            </p:cNvPr>
            <p:cNvSpPr/>
            <p:nvPr/>
          </p:nvSpPr>
          <p:spPr>
            <a:xfrm>
              <a:off x="2095534" y="-953508"/>
              <a:ext cx="1921836" cy="600450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ja-JP" altLang="en-US"/>
            </a:p>
          </p:txBody>
        </p:sp>
      </p:grp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F1D166A-44DC-0D41-8A8D-90BF71E6B029}"/>
              </a:ext>
            </a:extLst>
          </p:cNvPr>
          <p:cNvSpPr txBox="1"/>
          <p:nvPr/>
        </p:nvSpPr>
        <p:spPr>
          <a:xfrm>
            <a:off x="5570751" y="634112"/>
            <a:ext cx="3049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b) Stratified by RWT</a:t>
            </a:r>
            <a:r>
              <a:rPr lang="en-US" altLang="ja-JP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IVS+PW</a:t>
            </a: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C1EA7BD-3DDE-F049-AE70-BA4C88345912}"/>
              </a:ext>
            </a:extLst>
          </p:cNvPr>
          <p:cNvSpPr txBox="1"/>
          <p:nvPr/>
        </p:nvSpPr>
        <p:spPr>
          <a:xfrm>
            <a:off x="8624081" y="1372487"/>
            <a:ext cx="19907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og-rank, </a:t>
            </a:r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図 55">
            <a:extLst>
              <a:ext uri="{FF2B5EF4-FFF2-40B4-BE49-F238E27FC236}">
                <a16:creationId xmlns:a16="http://schemas.microsoft.com/office/drawing/2014/main" id="{97624F30-2FE4-954F-A7A2-09A0BA02BB7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10997475" y="1372487"/>
            <a:ext cx="5029202" cy="4114800"/>
          </a:xfrm>
          <a:prstGeom prst="rect">
            <a:avLst/>
          </a:prstGeom>
        </p:spPr>
      </p:pic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5C753C60-C8A2-2945-9263-C1EE65B110EB}"/>
              </a:ext>
            </a:extLst>
          </p:cNvPr>
          <p:cNvGrpSpPr/>
          <p:nvPr/>
        </p:nvGrpSpPr>
        <p:grpSpPr>
          <a:xfrm>
            <a:off x="11820041" y="2618992"/>
            <a:ext cx="1933200" cy="600450"/>
            <a:chOff x="1844430" y="358925"/>
            <a:chExt cx="1921836" cy="600450"/>
          </a:xfrm>
        </p:grpSpPr>
        <p:grpSp>
          <p:nvGrpSpPr>
            <p:cNvPr id="60" name="グループ化 59">
              <a:extLst>
                <a:ext uri="{FF2B5EF4-FFF2-40B4-BE49-F238E27FC236}">
                  <a16:creationId xmlns:a16="http://schemas.microsoft.com/office/drawing/2014/main" id="{7669401C-A994-C84A-A0E4-FFDD1D92932A}"/>
                </a:ext>
              </a:extLst>
            </p:cNvPr>
            <p:cNvGrpSpPr/>
            <p:nvPr/>
          </p:nvGrpSpPr>
          <p:grpSpPr>
            <a:xfrm>
              <a:off x="2009670" y="391613"/>
              <a:ext cx="1519972" cy="535074"/>
              <a:chOff x="2009670" y="424301"/>
              <a:chExt cx="1519972" cy="535074"/>
            </a:xfrm>
          </p:grpSpPr>
          <p:grpSp>
            <p:nvGrpSpPr>
              <p:cNvPr id="62" name="グループ化 61">
                <a:extLst>
                  <a:ext uri="{FF2B5EF4-FFF2-40B4-BE49-F238E27FC236}">
                    <a16:creationId xmlns:a16="http://schemas.microsoft.com/office/drawing/2014/main" id="{BBDDC8F0-B4ED-324D-8931-863C5EFE9A56}"/>
                  </a:ext>
                </a:extLst>
              </p:cNvPr>
              <p:cNvGrpSpPr/>
              <p:nvPr/>
            </p:nvGrpSpPr>
            <p:grpSpPr>
              <a:xfrm>
                <a:off x="2009670" y="636210"/>
                <a:ext cx="1519972" cy="323165"/>
                <a:chOff x="-240703" y="483810"/>
                <a:chExt cx="1519972" cy="323165"/>
              </a:xfrm>
            </p:grpSpPr>
            <p:sp>
              <p:nvSpPr>
                <p:cNvPr id="66" name="テキスト ボックス 65">
                  <a:extLst>
                    <a:ext uri="{FF2B5EF4-FFF2-40B4-BE49-F238E27FC236}">
                      <a16:creationId xmlns:a16="http://schemas.microsoft.com/office/drawing/2014/main" id="{2E9FFD64-7ED0-1243-87C4-143FE7B203CF}"/>
                    </a:ext>
                  </a:extLst>
                </p:cNvPr>
                <p:cNvSpPr txBox="1"/>
                <p:nvPr/>
              </p:nvSpPr>
              <p:spPr>
                <a:xfrm>
                  <a:off x="1153" y="483810"/>
                  <a:ext cx="1278116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500">
                      <a:latin typeface="Arial" panose="020B0604020202020204" pitchFamily="34" charset="0"/>
                      <a:cs typeface="Arial" panose="020B0604020202020204" pitchFamily="34" charset="0"/>
                    </a:rPr>
                    <a:t>High-RWT</a:t>
                  </a:r>
                  <a:r>
                    <a:rPr lang="en-US" altLang="ja-JP" sz="1500" baseline="-25000">
                      <a:latin typeface="Arial" panose="020B0604020202020204" pitchFamily="34" charset="0"/>
                      <a:cs typeface="Arial" panose="020B0604020202020204" pitchFamily="34" charset="0"/>
                    </a:rPr>
                    <a:t>IVS</a:t>
                  </a:r>
                  <a:endParaRPr lang="ja-JP" altLang="en-US" sz="1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7" name="直線コネクタ 66">
                  <a:extLst>
                    <a:ext uri="{FF2B5EF4-FFF2-40B4-BE49-F238E27FC236}">
                      <a16:creationId xmlns:a16="http://schemas.microsoft.com/office/drawing/2014/main" id="{583B16C8-A949-894E-A09C-5D1379A563E2}"/>
                    </a:ext>
                  </a:extLst>
                </p:cNvPr>
                <p:cNvCxnSpPr/>
                <p:nvPr/>
              </p:nvCxnSpPr>
              <p:spPr>
                <a:xfrm>
                  <a:off x="-240703" y="645392"/>
                  <a:ext cx="277200" cy="0"/>
                </a:xfrm>
                <a:prstGeom prst="line">
                  <a:avLst/>
                </a:prstGeom>
                <a:ln w="22860">
                  <a:solidFill>
                    <a:srgbClr val="00702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" name="グループ化 62">
                <a:extLst>
                  <a:ext uri="{FF2B5EF4-FFF2-40B4-BE49-F238E27FC236}">
                    <a16:creationId xmlns:a16="http://schemas.microsoft.com/office/drawing/2014/main" id="{CC15BF14-A44B-8A45-B210-22EE62B7BE08}"/>
                  </a:ext>
                </a:extLst>
              </p:cNvPr>
              <p:cNvGrpSpPr/>
              <p:nvPr/>
            </p:nvGrpSpPr>
            <p:grpSpPr>
              <a:xfrm>
                <a:off x="2009670" y="424301"/>
                <a:ext cx="1476945" cy="323165"/>
                <a:chOff x="1857270" y="194771"/>
                <a:chExt cx="1476945" cy="323165"/>
              </a:xfrm>
            </p:grpSpPr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B2928826-C827-A349-9438-FD13C0E81959}"/>
                    </a:ext>
                  </a:extLst>
                </p:cNvPr>
                <p:cNvSpPr txBox="1"/>
                <p:nvPr/>
              </p:nvSpPr>
              <p:spPr>
                <a:xfrm>
                  <a:off x="2099126" y="194771"/>
                  <a:ext cx="1235089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w-RWT</a:t>
                  </a:r>
                  <a:r>
                    <a:rPr lang="en-US" altLang="ja-JP" sz="15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VS</a:t>
                  </a:r>
                  <a:endParaRPr lang="ja-JP" altLang="en-US" sz="1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5" name="直線コネクタ 64">
                  <a:extLst>
                    <a:ext uri="{FF2B5EF4-FFF2-40B4-BE49-F238E27FC236}">
                      <a16:creationId xmlns:a16="http://schemas.microsoft.com/office/drawing/2014/main" id="{65E122DC-82C7-EF4B-90AA-4F46D71F404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57270" y="356353"/>
                  <a:ext cx="277200" cy="1"/>
                </a:xfrm>
                <a:prstGeom prst="line">
                  <a:avLst/>
                </a:prstGeom>
                <a:ln w="22860">
                  <a:solidFill>
                    <a:srgbClr val="3BC5A2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FF8A027C-0389-5342-B0BE-90CFBE948693}"/>
                </a:ext>
              </a:extLst>
            </p:cNvPr>
            <p:cNvSpPr/>
            <p:nvPr/>
          </p:nvSpPr>
          <p:spPr>
            <a:xfrm>
              <a:off x="1844430" y="358925"/>
              <a:ext cx="1921836" cy="600450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ja-JP" altLang="en-US"/>
            </a:p>
          </p:txBody>
        </p:sp>
      </p:grp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80B58F0D-1F6E-4E44-9154-B9D8CD03EF88}"/>
              </a:ext>
            </a:extLst>
          </p:cNvPr>
          <p:cNvSpPr txBox="1"/>
          <p:nvPr/>
        </p:nvSpPr>
        <p:spPr>
          <a:xfrm>
            <a:off x="10982607" y="634112"/>
            <a:ext cx="26988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c) Stratified by RWT</a:t>
            </a:r>
            <a:r>
              <a:rPr lang="en-US" altLang="ja-JP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IVS</a:t>
            </a: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FA984DC-96CD-0F42-BC9E-9D95D3DD6331}"/>
              </a:ext>
            </a:extLst>
          </p:cNvPr>
          <p:cNvSpPr txBox="1"/>
          <p:nvPr/>
        </p:nvSpPr>
        <p:spPr>
          <a:xfrm>
            <a:off x="13837219" y="1372487"/>
            <a:ext cx="19907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og-rank, </a:t>
            </a:r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077</a:t>
            </a:r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EAEE70D-4624-0548-B1EF-1D0F4B2F4AF1}"/>
              </a:ext>
            </a:extLst>
          </p:cNvPr>
          <p:cNvSpPr txBox="1"/>
          <p:nvPr/>
        </p:nvSpPr>
        <p:spPr>
          <a:xfrm>
            <a:off x="237602" y="166481"/>
            <a:ext cx="111665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 S1.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Kaplan-Meier Curves for all-cause mortality stratified by the stratified RWTs by the best cut-off.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823E4E9-1754-1A4C-BDFF-22B89A439C1A}"/>
              </a:ext>
            </a:extLst>
          </p:cNvPr>
          <p:cNvSpPr txBox="1"/>
          <p:nvPr/>
        </p:nvSpPr>
        <p:spPr>
          <a:xfrm>
            <a:off x="260002" y="5645764"/>
            <a:ext cx="9395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The best cut off value of RWTs were obtained from Youden index in the ROCs for 90 days-mortality.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823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</TotalTime>
  <Words>82</Words>
  <Application>Microsoft Macintosh PowerPoint</Application>
  <PresentationFormat>ユーザー設定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guchi</dc:creator>
  <cp:lastModifiedBy>山口　怜</cp:lastModifiedBy>
  <cp:revision>60</cp:revision>
  <dcterms:created xsi:type="dcterms:W3CDTF">2018-08-06T23:04:44Z</dcterms:created>
  <dcterms:modified xsi:type="dcterms:W3CDTF">2019-11-23T02:45:14Z</dcterms:modified>
</cp:coreProperties>
</file>